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3" r:id="rId1"/>
  </p:sldMasterIdLst>
  <p:notesMasterIdLst>
    <p:notesMasterId r:id="rId3"/>
  </p:notesMasterIdLst>
  <p:sldIdLst>
    <p:sldId id="28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e, Hongli" initials="XH" lastIdx="8" clrIdx="0">
    <p:extLst/>
  </p:cmAuthor>
  <p:cmAuthor id="2" name="Tang, Yuhong" initials="TY" lastIdx="1" clrIdx="1">
    <p:extLst/>
  </p:cmAuthor>
  <p:cmAuthor id="3" name="Blancaflor, Elison" initials="BE" lastIdx="5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13" autoAdjust="0"/>
    <p:restoredTop sz="93359" autoAdjust="0"/>
  </p:normalViewPr>
  <p:slideViewPr>
    <p:cSldViewPr snapToGrid="0">
      <p:cViewPr varScale="1">
        <p:scale>
          <a:sx n="107" d="100"/>
          <a:sy n="107" d="100"/>
        </p:scale>
        <p:origin x="-45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5" d="100"/>
        <a:sy n="95" d="100"/>
      </p:scale>
      <p:origin x="0" y="-13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AF8FC-282C-4D50-A8E4-D2E2BE1ACA9E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F050B-F196-4082-B381-D05887F97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7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21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96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797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688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913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817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394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39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55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82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37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B32A-AD5C-421A-AAFC-29CA47166070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1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98298" y="0"/>
            <a:ext cx="895936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Additional fil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6: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Table </a:t>
            </a:r>
            <a:r>
              <a:rPr lang="en-US" sz="1200" b="1" dirty="0" smtClean="0">
                <a:latin typeface="Times New Roman" panose="02020603050405020304" pitchFamily="18" charset="0"/>
              </a:rPr>
              <a:t>S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3.  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Differentially-accumulated metabolites in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the 6-week-old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tems of WT,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 (</a:t>
            </a:r>
            <a:r>
              <a:rPr lang="en-US" sz="1200" b="1" i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f1)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</a:rPr>
              <a:t>ccoaomt1 (</a:t>
            </a:r>
            <a:r>
              <a:rPr lang="en-US" sz="1200" b="1" i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cc1)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and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ccoaomt1 (</a:t>
            </a:r>
            <a:r>
              <a:rPr lang="en-US" sz="1200" b="1" i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f1cc1) plants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election threshold for significant metabolites (marked with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*, up in red, down in blue)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is P&lt;0.05 (Student’s t-test)</a:t>
            </a:r>
            <a:r>
              <a:rPr lang="en-US" sz="1200" dirty="0"/>
              <a:t>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3415143"/>
              </p:ext>
            </p:extLst>
          </p:nvPr>
        </p:nvGraphicFramePr>
        <p:xfrm>
          <a:off x="729758" y="606666"/>
          <a:ext cx="7547466" cy="6046487"/>
        </p:xfrm>
        <a:graphic>
          <a:graphicData uri="http://schemas.openxmlformats.org/drawingml/2006/table">
            <a:tbl>
              <a:tblPr/>
              <a:tblGrid>
                <a:gridCol w="1526150"/>
                <a:gridCol w="473514"/>
                <a:gridCol w="473514"/>
                <a:gridCol w="473514"/>
                <a:gridCol w="473514"/>
                <a:gridCol w="415926"/>
                <a:gridCol w="415926"/>
                <a:gridCol w="415926"/>
                <a:gridCol w="415926"/>
                <a:gridCol w="415926"/>
                <a:gridCol w="409526"/>
                <a:gridCol w="409526"/>
                <a:gridCol w="409526"/>
                <a:gridCol w="409526"/>
                <a:gridCol w="409526"/>
              </a:tblGrid>
              <a:tr h="110049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tes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t (*)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1004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f1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1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1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cc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aiacyl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gnan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ikim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8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5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5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2F75B5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2F75B5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2F75B5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i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napoyl-malic acid 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-tocopher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i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2,4-benzenetri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reoni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-oxo-proli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6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5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8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7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nylalani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r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3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9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5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nit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hydroxy-2-propeno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O-feruloyl-malic acid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ulic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oxo-adip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empfer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-inosit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ringic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id-4-O-glucosid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25 398 383 glucosid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nillic acid-4-O-glucosid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nap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ffinos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actin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-hydroxybenzo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reon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7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art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pestero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gmastano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01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4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4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52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uctos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6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3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1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6-anhydro-galactos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actos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2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3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0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0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-nonacosano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hydroxypropano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erol-1/3-P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hexacosan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sitoster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7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tam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9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1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3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7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-keto-glutar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galactosylglycero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ani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62 487 kaemferol conj.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08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5-dihydroxybenzoic acid-5-O-glucosid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3-diphosphoglycer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ros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96.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42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86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73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actosylglycerol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cinic acid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1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4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anolamine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6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8.9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2.7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5.3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0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2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8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6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</a:p>
                  </a:txBody>
                  <a:tcPr marL="4109" marR="4109" marT="41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604227" y="6653153"/>
            <a:ext cx="81661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 concentration (ug/g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sh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;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rbitol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quivalents). The retention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RT; min) and key mass-to-charge (m/z)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tios are positioned in front of tentatively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8171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933</TotalTime>
  <Words>753</Words>
  <Application>Microsoft Office PowerPoint</Application>
  <PresentationFormat>On-screen Show (4:3)</PresentationFormat>
  <Paragraphs>7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Hongli</dc:creator>
  <cp:lastModifiedBy>Shine David S.A.</cp:lastModifiedBy>
  <cp:revision>544</cp:revision>
  <cp:lastPrinted>2017-10-20T14:57:19Z</cp:lastPrinted>
  <dcterms:created xsi:type="dcterms:W3CDTF">2017-05-21T20:10:06Z</dcterms:created>
  <dcterms:modified xsi:type="dcterms:W3CDTF">2019-04-30T09:25:41Z</dcterms:modified>
</cp:coreProperties>
</file>